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正方形/長方形 32">
            <a:extLst>
              <a:ext uri="{FF2B5EF4-FFF2-40B4-BE49-F238E27FC236}">
                <a16:creationId xmlns:a16="http://schemas.microsoft.com/office/drawing/2014/main" id="{BA7DB589-835A-40B0-8017-F1D8E240D9FE}"/>
              </a:ext>
            </a:extLst>
          </p:cNvPr>
          <p:cNvSpPr/>
          <p:nvPr/>
        </p:nvSpPr>
        <p:spPr>
          <a:xfrm>
            <a:off x="205740" y="8085322"/>
            <a:ext cx="630936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4. Histological images of the lungs at 4 weeks of infection in C57BL/6 mice by hematoxylin-eosin staining. Bars indicate 50 </a:t>
            </a:r>
            <a:r>
              <a:rPr lang="en-US" altLang="ja-JP" sz="14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m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D8EDA0FF-9DEA-4661-969C-6AB7058688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440" y="265083"/>
            <a:ext cx="6639119" cy="64135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8271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27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5</cp:revision>
  <dcterms:created xsi:type="dcterms:W3CDTF">2022-12-07T03:50:42Z</dcterms:created>
  <dcterms:modified xsi:type="dcterms:W3CDTF">2022-12-07T04:00:26Z</dcterms:modified>
</cp:coreProperties>
</file>